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4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6501"/>
    <p:restoredTop sz="95833"/>
  </p:normalViewPr>
  <p:slideViewPr>
    <p:cSldViewPr snapToGrid="0" snapToObjects="1">
      <p:cViewPr varScale="1">
        <p:scale>
          <a:sx n="77" d="100"/>
          <a:sy n="77" d="100"/>
        </p:scale>
        <p:origin x="13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829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03972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20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2965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0722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883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6481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127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42734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471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5433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F0411-0976-DB4B-A5DF-D633438C94EF}" type="datetimeFigureOut">
              <a:rPr lang="en-GB" smtClean="0"/>
              <a:t>21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A2823-E57E-DF42-A5B9-858F62148F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3603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C40999B-FB48-E24C-B342-D7CBF65B4A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874" y="416778"/>
            <a:ext cx="3454400" cy="2184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52697B1-511F-0A4D-96AB-1F87F6FB6B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874" y="2601178"/>
            <a:ext cx="3467100" cy="21844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01A6C47-5531-8B41-B10A-E40C9A3B67F5}"/>
              </a:ext>
            </a:extLst>
          </p:cNvPr>
          <p:cNvSpPr/>
          <p:nvPr/>
        </p:nvSpPr>
        <p:spPr>
          <a:xfrm>
            <a:off x="168873" y="4953000"/>
            <a:ext cx="5921683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imple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inear regression displayed a significantly positive correlation between admission CysC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RACE/CRUSADE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core.</a:t>
            </a:r>
            <a:r>
              <a: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4374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88</TotalTime>
  <Words>19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u Bowen</dc:creator>
  <cp:lastModifiedBy>Lou Bowen</cp:lastModifiedBy>
  <cp:revision>50</cp:revision>
  <dcterms:created xsi:type="dcterms:W3CDTF">2021-05-01T13:52:09Z</dcterms:created>
  <dcterms:modified xsi:type="dcterms:W3CDTF">2022-03-21T11:54:49Z</dcterms:modified>
</cp:coreProperties>
</file>